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9" r:id="rId4"/>
    <p:sldId id="261" r:id="rId5"/>
    <p:sldId id="264" r:id="rId6"/>
    <p:sldId id="267" r:id="rId7"/>
    <p:sldId id="268" r:id="rId8"/>
  </p:sldIdLst>
  <p:sldSz cx="6858000" cy="12192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3" d="100"/>
          <a:sy n="63" d="100"/>
        </p:scale>
        <p:origin x="27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995508"/>
            <a:ext cx="5143500" cy="424504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6404254"/>
            <a:ext cx="5143500" cy="294386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649175"/>
            <a:ext cx="1478756" cy="1033317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649175"/>
            <a:ext cx="4350544" cy="1033317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3039834"/>
            <a:ext cx="5915025" cy="50720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8159849"/>
            <a:ext cx="5915025" cy="266726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3245875"/>
            <a:ext cx="2914650" cy="77364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3245875"/>
            <a:ext cx="2914650" cy="77364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49175"/>
            <a:ext cx="5915025" cy="23567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989029"/>
            <a:ext cx="2901255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4453905"/>
            <a:ext cx="2901255" cy="65510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989029"/>
            <a:ext cx="2915543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4453905"/>
            <a:ext cx="2915543" cy="65510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649175"/>
            <a:ext cx="5915025" cy="2356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3245875"/>
            <a:ext cx="5915025" cy="77364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11301291"/>
            <a:ext cx="2314575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/>
        </p:nvGraphicFramePr>
        <p:xfrm>
          <a:off x="471170" y="2959100"/>
          <a:ext cx="5916295" cy="269621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89760"/>
                <a:gridCol w="1409065"/>
                <a:gridCol w="1240790"/>
                <a:gridCol w="1376680"/>
              </a:tblGrid>
              <a:tr h="387350">
                <a:tc>
                  <a:txBody>
                    <a:bodyPr/>
                    <a:lstStyle/>
                    <a:p>
                      <a:pPr indent="0" algn="ctr">
                        <a:lnSpc>
                          <a:spcPct val="190000"/>
                        </a:lnSpc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rameters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90000"/>
                        </a:lnSpc>
                        <a:buNone/>
                      </a:pPr>
                      <a:r>
                        <a:rPr lang="en-US" sz="1200" b="1" i="1">
                          <a:latin typeface="Times New Roman" panose="02020603050405020304" charset="0"/>
                          <a:cs typeface="Times New Roman" panose="02020603050405020304" charset="0"/>
                        </a:rPr>
                        <a:t>WT</a:t>
                      </a:r>
                      <a:endParaRPr lang="en-US" altLang="en-US" sz="1200" b="1" i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90000"/>
                        </a:lnSpc>
                        <a:buNone/>
                      </a:pPr>
                      <a:r>
                        <a:rPr lang="en-US" sz="1200" b="1" i="1">
                          <a:latin typeface="Times New Roman" panose="02020603050405020304" charset="0"/>
                          <a:cs typeface="Times New Roman" panose="02020603050405020304" charset="0"/>
                        </a:rPr>
                        <a:t>MU1</a:t>
                      </a:r>
                      <a:endParaRPr lang="en-US" altLang="en-US" sz="1200" b="1" i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90000"/>
                        </a:lnSpc>
                        <a:buNone/>
                      </a:pPr>
                      <a:r>
                        <a:rPr lang="en-US" sz="1200" b="1" i="1">
                          <a:latin typeface="Times New Roman" panose="02020603050405020304" charset="0"/>
                          <a:cs typeface="Times New Roman" panose="02020603050405020304" charset="0"/>
                        </a:rPr>
                        <a:t>MU2</a:t>
                      </a:r>
                      <a:endParaRPr lang="en-US" altLang="en-US" sz="1200" b="1" i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41630"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otal raw reads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74349052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276930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593196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51155"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otal clean reads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249240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169568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489343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8610"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Error (%)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0.02 %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0.02 %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0.02 %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680"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Q20 percentag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7.25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7.62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7.46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Q30 percentag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2.66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3.53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3.20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49250"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 percentag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3055"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C percentag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9.17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9.97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9.29 %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2" name="文本框 101"/>
          <p:cNvSpPr txBox="1"/>
          <p:nvPr/>
        </p:nvSpPr>
        <p:spPr>
          <a:xfrm>
            <a:off x="405130" y="2113280"/>
            <a:ext cx="5982335" cy="58356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600">
                <a:latin typeface="Times New Roman" panose="02020603050405020304" charset="0"/>
                <a:cs typeface="Calibri" panose="020F0502020204030204" charset="0"/>
              </a:rPr>
              <a:t>Tab 1. Summary statistics of transcriptome sequencing for three different phenotypes of </a:t>
            </a:r>
            <a:r>
              <a:rPr lang="en-US" sz="1600" i="1">
                <a:latin typeface="Times New Roman" panose="02020603050405020304" charset="0"/>
                <a:cs typeface="Calibri" panose="020F0502020204030204" charset="0"/>
              </a:rPr>
              <a:t>Pristella maxillaris</a:t>
            </a:r>
            <a:endParaRPr lang="en-US" sz="1600" i="1">
              <a:latin typeface="Times New Roman" panose="02020603050405020304" charset="0"/>
              <a:cs typeface="Calibri" panose="020F05020202040302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文本框 101"/>
          <p:cNvSpPr txBox="1"/>
          <p:nvPr/>
        </p:nvSpPr>
        <p:spPr>
          <a:xfrm>
            <a:off x="267335" y="830580"/>
            <a:ext cx="6314440" cy="58356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600" b="1">
                <a:latin typeface="Times New Roman" panose="02020603050405020304" charset="0"/>
                <a:ea typeface="宋体" panose="02010600030101010101" pitchFamily="2" charset="-122"/>
              </a:rPr>
              <a:t>Tab 2.</a:t>
            </a:r>
            <a:r>
              <a:rPr lang="en-US" sz="1600" b="0">
                <a:latin typeface="Times New Roman" panose="02020603050405020304" charset="0"/>
                <a:ea typeface="宋体" panose="02010600030101010101" pitchFamily="2" charset="-122"/>
              </a:rPr>
              <a:t> Kyoto Encyclopedia of Genes and Genomes (KEGG) functional analysis of DEGs in MU1 </a:t>
            </a:r>
            <a:r>
              <a:rPr lang="en-US" sz="1600" b="0" i="1">
                <a:latin typeface="Times New Roman" panose="02020603050405020304" charset="0"/>
                <a:ea typeface="宋体" panose="02010600030101010101" pitchFamily="2" charset="-122"/>
              </a:rPr>
              <a:t>vs</a:t>
            </a:r>
            <a:r>
              <a:rPr lang="en-US" sz="1600" b="0">
                <a:latin typeface="Times New Roman" panose="02020603050405020304" charset="0"/>
                <a:ea typeface="宋体" panose="02010600030101010101" pitchFamily="2" charset="-122"/>
              </a:rPr>
              <a:t> WT(a), MU2 </a:t>
            </a:r>
            <a:r>
              <a:rPr lang="en-US" sz="1600" b="0" i="1">
                <a:latin typeface="Times New Roman" panose="02020603050405020304" charset="0"/>
                <a:ea typeface="宋体" panose="02010600030101010101" pitchFamily="2" charset="-122"/>
              </a:rPr>
              <a:t>vs</a:t>
            </a:r>
            <a:r>
              <a:rPr lang="en-US" sz="1600" b="0">
                <a:latin typeface="Times New Roman" panose="02020603050405020304" charset="0"/>
                <a:ea typeface="宋体" panose="02010600030101010101" pitchFamily="2" charset="-122"/>
              </a:rPr>
              <a:t> WT</a:t>
            </a:r>
            <a:r>
              <a:rPr lang="en-US" sz="16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(b)</a:t>
            </a:r>
            <a:r>
              <a:rPr lang="en-US" sz="1600" b="0">
                <a:latin typeface="Times New Roman" panose="02020603050405020304" charset="0"/>
                <a:ea typeface="宋体" panose="02010600030101010101" pitchFamily="2" charset="-122"/>
              </a:rPr>
              <a:t> and MU1 </a:t>
            </a:r>
            <a:r>
              <a:rPr lang="en-US" sz="1600" b="0" i="1">
                <a:latin typeface="Times New Roman" panose="02020603050405020304" charset="0"/>
                <a:ea typeface="宋体" panose="02010600030101010101" pitchFamily="2" charset="-122"/>
              </a:rPr>
              <a:t>vs</a:t>
            </a:r>
            <a:r>
              <a:rPr lang="en-US" sz="1600" b="0">
                <a:latin typeface="Times New Roman" panose="02020603050405020304" charset="0"/>
                <a:ea typeface="宋体" panose="02010600030101010101" pitchFamily="2" charset="-122"/>
              </a:rPr>
              <a:t> MU2 (c).</a:t>
            </a:r>
            <a:endParaRPr lang="en-US" altLang="en-US" sz="1600" b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graphicFrame>
        <p:nvGraphicFramePr>
          <p:cNvPr id="2" name="表格 1"/>
          <p:cNvGraphicFramePr/>
          <p:nvPr/>
        </p:nvGraphicFramePr>
        <p:xfrm>
          <a:off x="510540" y="1530985"/>
          <a:ext cx="5828030" cy="54213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59635"/>
                <a:gridCol w="1503680"/>
                <a:gridCol w="1033145"/>
                <a:gridCol w="1131570"/>
              </a:tblGrid>
              <a:tr h="253365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thway（MU1</a:t>
                      </a: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vs</a:t>
                      </a: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WT, a）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EGs*with Pathway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q-Value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thway ID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114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ibosom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69E-31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1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8605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NA replica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.13E-0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3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1775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ismatch repair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356677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43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019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ystemic lupus erythematosus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66E-1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32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0665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ucleotide excision repair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.52E-0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42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178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taphylococcus aureus infec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21661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15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9555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lutathione metabolism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1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48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209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NA degrada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77E-0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1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130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yrimidine metabolism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.45E-07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24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0665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Legionellosis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3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1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13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1529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ntigen processing and presenta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.81E-0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61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0665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ell cycl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10E-0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11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003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Oxidative phosphoryla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26E-0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19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130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rkinson’s diseas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.55E-0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01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019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NA transport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.41E-07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13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2565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1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.54E-0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23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210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APK signaling pathway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91439" marR="91439" marT="45719" marB="45719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99778698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91439" marR="91439" marT="45719" marB="45719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01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495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AMP signaling pathway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91439" marR="91439" marT="45719" marB="45719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99629798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91439" marR="91439" marT="45719" marB="45719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02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210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91439" marR="91439" marT="45719" marB="45719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91032612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91439" marR="91439" marT="45719" marB="45719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91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9230"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yrosine metabolism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91439" marR="91439" marT="45719" marB="45719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5019486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91439" marR="91439" marT="45719" marB="45719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1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35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7" name="表格 6"/>
          <p:cNvGraphicFramePr/>
          <p:nvPr/>
        </p:nvGraphicFramePr>
        <p:xfrm>
          <a:off x="889000" y="5891213"/>
          <a:ext cx="0" cy="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0"/>
                <a:gridCol w="0"/>
              </a:tblGrid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b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/>
          <p:nvPr/>
        </p:nvGraphicFramePr>
        <p:xfrm>
          <a:off x="621030" y="2725420"/>
          <a:ext cx="5758180" cy="557657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65680"/>
                <a:gridCol w="1517650"/>
                <a:gridCol w="1029335"/>
                <a:gridCol w="945515"/>
              </a:tblGrid>
              <a:tr h="280035">
                <a:tc>
                  <a:txBody>
                    <a:bodyPr/>
                    <a:lstStyle/>
                    <a:p>
                      <a:pPr indent="0" algn="ctr">
                        <a:lnSpc>
                          <a:spcPct val="130000"/>
                        </a:lnSpc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thway（MU2</a:t>
                      </a: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vs</a:t>
                      </a: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WT, b）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30000"/>
                        </a:lnSpc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EGs*with Pathway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30000"/>
                        </a:lnSpc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q-Value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30000"/>
                        </a:lnSpc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thway ID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6705">
                <a:tc>
                  <a:txBody>
                    <a:bodyPr/>
                    <a:lstStyle/>
                    <a:p>
                      <a:pPr indent="0" algn="ctr">
                        <a:lnSpc>
                          <a:spcPct val="13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yrimidine metabolism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3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3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25E-11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3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24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860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NA replica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3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.91E-11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3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95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ell cycl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.91E-11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11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241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ystemic lupus erythematosus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56E-0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32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90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1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92E-0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32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09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ucleotide excision repair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7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.80E-0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42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003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pliceosom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.56E-0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4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entose phosphate pathway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103465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03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257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ismatch repair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32084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43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082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NA polymeras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7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52237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2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273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taphylococcus aureus infec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547331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15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241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NA degrada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63509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1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101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lycine, serine and threonine metabolism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107530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26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16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ardiac muscle contrac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3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107530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26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987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ECM-receptor interac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3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205363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51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067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rkinson’s disease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207279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01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Oxidative phosphorylation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4989829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19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35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lycolysis / Gluconeogenesis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888746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01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1460"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yrosine metabolism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90654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350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860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2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822218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916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/>
        </p:nvGraphicFramePr>
        <p:xfrm>
          <a:off x="838200" y="2113915"/>
          <a:ext cx="5478145" cy="50485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536643"/>
                <a:gridCol w="1417295"/>
                <a:gridCol w="685864"/>
                <a:gridCol w="838343"/>
              </a:tblGrid>
              <a:tr h="311150">
                <a:tc>
                  <a:txBody>
                    <a:bodyPr/>
                    <a:lstStyle/>
                    <a:p>
                      <a:pPr indent="0" algn="ctr">
                        <a:lnSpc>
                          <a:spcPct val="140000"/>
                        </a:lnSpc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thway（MU1</a:t>
                      </a: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vs</a:t>
                      </a: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U2, c）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40000"/>
                        </a:lnSpc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EGs*with Pathway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40000"/>
                        </a:lnSpc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q-Value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40000"/>
                        </a:lnSpc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thway ID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33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ibosom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9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75E-2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1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ECM-receptor interactio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63E-1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51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33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rotein digestion and absorptio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.32E-18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97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33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ight junctio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.50E-1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53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thogenic Escherichia coli infectio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08E-0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13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33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roteasome</a:t>
                      </a:r>
                      <a:endParaRPr lang="en-US" altLang="en-US" sz="1100" b="0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32E-0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5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965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lycolysis / Glucone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9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90E-0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01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Hypertrophic cardiomyopathy (HCM)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.50E-06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41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33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NA replicatio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6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.74E-0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3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965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I3K-Akt signaling pathway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9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509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15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965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Focal adhesion</a:t>
                      </a:r>
                      <a:endParaRPr lang="en-US" altLang="en-US" sz="1100" b="0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08E-0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51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965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ilated cardiomyopathy (DCM)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20E-0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41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ystemic lupus erythematosu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.36E-0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532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38150"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tabolism of xenobiotics by cytochrome P45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4753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98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33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8004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23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33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entose pphosphate athway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198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03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pliceosom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.88E-0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304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33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ardiac muscle contractio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21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26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ntigen processing and presentatio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41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461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765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rginine biosynth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045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dirty="0" err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o00220</a:t>
                      </a:r>
                      <a:endParaRPr lang="en-US" altLang="en-US" sz="1100" b="0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600074" y="7287260"/>
            <a:ext cx="5954395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indent="0" algn="l"/>
            <a:r>
              <a:rPr lang="en-US" sz="1200" dirty="0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*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DEG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, differentially </a:t>
            </a:r>
            <a:r>
              <a:rPr lang="en-US" sz="1200" dirty="0">
                <a:latin typeface="Times New Roman" panose="02020603050405020304" charset="0"/>
                <a:cs typeface="Calibri" panose="020F0502020204030204" charset="0"/>
                <a:sym typeface="+mn-ea"/>
              </a:rPr>
              <a:t>expresse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 genes, which was identified by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DEGseq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 package.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DEG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 between the two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samples were selected with the following filter criteria: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log2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charset="0"/>
                <a:cs typeface="Calibri" panose="020F0502020204030204" charset="0"/>
                <a:sym typeface="+mn-ea"/>
              </a:rPr>
              <a:t> transcript abundance ratio ≥1 and FDR (false discovery ratio)≤0.001.</a:t>
            </a:r>
            <a:endParaRPr lang="en-US" altLang="en-US" sz="1200" dirty="0">
              <a:solidFill>
                <a:srgbClr val="000000"/>
              </a:solidFill>
              <a:latin typeface="Times New Roman" panose="02020603050405020304" charset="0"/>
              <a:cs typeface="Calibri" panose="020F0502020204030204" charset="0"/>
              <a:sym typeface="+mn-ea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73380" y="1939925"/>
            <a:ext cx="5844540" cy="5835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indent="0"/>
            <a:r>
              <a:rPr lang="en-US" sz="1600" b="1">
                <a:latin typeface="Times New Roman" panose="02020603050405020304" charset="0"/>
                <a:sym typeface="+mn-ea"/>
              </a:rPr>
              <a:t>Table 3. </a:t>
            </a:r>
            <a:r>
              <a:rPr lang="en-US" sz="1600">
                <a:latin typeface="Times New Roman" panose="02020603050405020304" charset="0"/>
                <a:sym typeface="+mn-ea"/>
              </a:rPr>
              <a:t>KEGG pathway analysis of positively selected genes involved in melanophores in </a:t>
            </a:r>
            <a:r>
              <a:rPr lang="en-US" sz="1600" i="1">
                <a:latin typeface="Times New Roman" panose="02020603050405020304" charset="0"/>
                <a:sym typeface="+mn-ea"/>
              </a:rPr>
              <a:t>Pristella maxillaris</a:t>
            </a:r>
            <a:endParaRPr lang="en-US" sz="1600" i="1">
              <a:latin typeface="Times New Roman" panose="02020603050405020304" charset="0"/>
              <a:sym typeface="+mn-ea"/>
            </a:endParaRPr>
          </a:p>
        </p:txBody>
      </p:sp>
      <p:graphicFrame>
        <p:nvGraphicFramePr>
          <p:cNvPr id="4" name="表格 3"/>
          <p:cNvGraphicFramePr/>
          <p:nvPr/>
        </p:nvGraphicFramePr>
        <p:xfrm>
          <a:off x="468629" y="2798445"/>
          <a:ext cx="5654041" cy="4495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8713"/>
                <a:gridCol w="596171"/>
                <a:gridCol w="2358198"/>
                <a:gridCol w="1330959"/>
              </a:tblGrid>
              <a:tr h="3657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ene ID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ene Name</a:t>
                      </a:r>
                      <a:endParaRPr lang="en-US" altLang="en-US" sz="1100" b="1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iscription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1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KEGG Pathway</a:t>
                      </a:r>
                      <a:endParaRPr lang="en-US" altLang="en-US" sz="1100" b="1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33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7078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adh6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lcohol dehydrogenase 6-lik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yrosine metabolism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14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15576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gst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lutathione S-transferase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rug metabolism - cytochrome P45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2728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wnt8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rotein Wnt-8a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Wnt/β-catenin signaling pathway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4092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fzd2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frizzled 2</a:t>
                      </a:r>
                      <a:endParaRPr 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9205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asip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gouti-signaling protei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135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4548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creb3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yclic AMP-responsive element-binding protein 3-like protein 4,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76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3365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map2k2</a:t>
                      </a:r>
                      <a:endParaRPr lang="en-US" altLang="en-US" sz="1100" b="0" i="1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ual specificity mitogen-activated protein kinase kinase 2-lik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MAPK signaling pathway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6812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gnai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uanine nucleotide-binding protein G(o) subunit alpha isoform X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6579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cam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almodulin-lik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5871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bad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bcl2 antagonist of cell death-like isoform X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ma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78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10071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cdk4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yclin-dependent kinase 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ma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8189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dvl2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egment polarity protein dishevelled homolog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6245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kras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TPase KRas isoform X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7864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camk2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alcium/calmodulin-dependent protein kinase type II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anogenesis</a:t>
                      </a:r>
                      <a:endParaRPr lang="en-US" altLang="en-US" sz="1100" b="0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文本框 100"/>
          <p:cNvSpPr txBox="1"/>
          <p:nvPr/>
        </p:nvSpPr>
        <p:spPr>
          <a:xfrm>
            <a:off x="262255" y="2685415"/>
            <a:ext cx="5544185" cy="74485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Tab 4.</a:t>
            </a:r>
            <a:r>
              <a:rPr lang="en-US" sz="1600" b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KEGG pathway analysis of positively selected genes involved in iridophores metabolism in </a:t>
            </a:r>
            <a:r>
              <a:rPr lang="en-US" sz="1600" b="0" i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ristella maxillaris</a:t>
            </a:r>
            <a:endParaRPr lang="en-US" sz="1600" b="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indent="0"/>
            <a:r>
              <a:rPr lang="en-US" sz="1050" b="0">
                <a:latin typeface="Calibri" panose="020F05020202040302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endParaRPr lang="zh-CN" altLang="en-US"/>
          </a:p>
        </p:txBody>
      </p:sp>
      <p:graphicFrame>
        <p:nvGraphicFramePr>
          <p:cNvPr id="2" name="表格 1"/>
          <p:cNvGraphicFramePr/>
          <p:nvPr/>
        </p:nvGraphicFramePr>
        <p:xfrm>
          <a:off x="563880" y="3430270"/>
          <a:ext cx="5681346" cy="51206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9913"/>
                <a:gridCol w="687226"/>
                <a:gridCol w="2387769"/>
                <a:gridCol w="1336438"/>
              </a:tblGrid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ene ID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ene Name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iscription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KEGG Pathway</a:t>
                      </a:r>
                      <a:endParaRPr lang="en-US" altLang="en-US" sz="1100" b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6011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latin typeface="Times New Roman" panose="02020603050405020304" charset="0"/>
                          <a:cs typeface="Times New Roman" panose="02020603050405020304" charset="0"/>
                        </a:rPr>
                        <a:t>ldh</a:t>
                      </a:r>
                      <a:endParaRPr lang="en-US" altLang="en-US" sz="1100" b="0" i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L-lactate dehydrogenase B-A chai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lycolytic pathway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6444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latin typeface="Times New Roman" panose="02020603050405020304" charset="0"/>
                          <a:cs typeface="Times New Roman" panose="02020603050405020304" charset="0"/>
                        </a:rPr>
                        <a:t>pk</a:t>
                      </a:r>
                      <a:endParaRPr lang="en-US" altLang="en-US" sz="1100" b="0" i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yruvate kinase PKM isoform X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57158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latin typeface="Times New Roman" panose="02020603050405020304" charset="0"/>
                          <a:cs typeface="Times New Roman" panose="02020603050405020304" charset="0"/>
                        </a:rPr>
                        <a:t>eno</a:t>
                      </a:r>
                      <a:endParaRPr lang="en-US" altLang="en-US" sz="1100" b="0" i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beta-enolas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lycolysis / Glucone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6328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latin typeface="Times New Roman" panose="02020603050405020304" charset="0"/>
                          <a:cs typeface="Times New Roman" panose="02020603050405020304" charset="0"/>
                        </a:rPr>
                        <a:t>aldo</a:t>
                      </a:r>
                      <a:endParaRPr lang="en-US" altLang="en-US" sz="1100" b="0" i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fructose-bisphosphate aldolase C-B-lik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lycolysis / Glucone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6159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9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bifunctional purine biosynthesis protein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45519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hprt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hypoxanthine-guanine phosphoribosyltransferas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5911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gam1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hosphoglycerate mutase 1-lik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lycolysis / Gluconeogenesis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51649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uk1a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uanylate kinase isoform X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49116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latin typeface="Times New Roman" panose="02020603050405020304" charset="0"/>
                          <a:cs typeface="Times New Roman" panose="02020603050405020304" charset="0"/>
                        </a:rPr>
                        <a:t>pfka</a:t>
                      </a:r>
                      <a:endParaRPr lang="en-US" altLang="en-US" sz="1100" b="0" i="1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-phosphofructokinase, muscle typ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entose phosphate pathway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7975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ktl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ransketolase-like protein 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entose phosphate pathway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64418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aldo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ransaldolas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entose phosphate pathway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34530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gd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-phosphogluconate dehydrogenase, decarboxylating-like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entose phosphate pathway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5287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impdh2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onophosphate dehydrogenase 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2111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dk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ucleoside diphosphate kinase-like isoform X1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luster-7922.62678 </a:t>
                      </a:r>
                      <a:endParaRPr 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en-US" sz="1100" b="0" i="1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gart</a:t>
                      </a:r>
                      <a:endParaRPr lang="en-US" altLang="en-US" sz="1100" b="0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rifunctional purine biosynthetic protein</a:t>
                      </a: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 </a:t>
                      </a: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denosine-3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urine metabolism</a:t>
                      </a:r>
                      <a:endParaRPr lang="en-US" altLang="en-US" sz="1100" b="0" dirty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44</Words>
  <Application>WPS 演示</Application>
  <PresentationFormat>宽屏</PresentationFormat>
  <Paragraphs>827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生命的独舞</cp:lastModifiedBy>
  <cp:revision>48</cp:revision>
  <dcterms:created xsi:type="dcterms:W3CDTF">2019-04-23T01:49:00Z</dcterms:created>
  <dcterms:modified xsi:type="dcterms:W3CDTF">2019-06-08T11:12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751</vt:lpwstr>
  </property>
</Properties>
</file>